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56" r:id="rId3"/>
    <p:sldId id="257" r:id="rId4"/>
    <p:sldId id="258" r:id="rId5"/>
    <p:sldId id="259" r:id="rId6"/>
    <p:sldId id="267" r:id="rId7"/>
    <p:sldId id="260" r:id="rId8"/>
    <p:sldId id="261" r:id="rId9"/>
    <p:sldId id="262" r:id="rId10"/>
    <p:sldId id="266" r:id="rId11"/>
    <p:sldId id="264" r:id="rId1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8363" autoAdjust="0"/>
    <p:restoredTop sz="94660"/>
  </p:normalViewPr>
  <p:slideViewPr>
    <p:cSldViewPr snapToGrid="0">
      <p:cViewPr varScale="1">
        <p:scale>
          <a:sx n="77" d="100"/>
          <a:sy n="77" d="100"/>
        </p:scale>
        <p:origin x="-2622" y="-9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5A210-0E15-4F55-963C-5BADE2DC5EF2}" type="datetimeFigureOut">
              <a:rPr lang="en-US" smtClean="0"/>
              <a:pPr/>
              <a:t>11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D5225-7804-4729-9698-E5AA13183FF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5A210-0E15-4F55-963C-5BADE2DC5EF2}" type="datetimeFigureOut">
              <a:rPr lang="en-US" smtClean="0"/>
              <a:pPr/>
              <a:t>11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D5225-7804-4729-9698-E5AA13183FF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5A210-0E15-4F55-963C-5BADE2DC5EF2}" type="datetimeFigureOut">
              <a:rPr lang="en-US" smtClean="0"/>
              <a:pPr/>
              <a:t>11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D5225-7804-4729-9698-E5AA13183FF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5A210-0E15-4F55-963C-5BADE2DC5EF2}" type="datetimeFigureOut">
              <a:rPr lang="en-US" smtClean="0"/>
              <a:pPr/>
              <a:t>11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D5225-7804-4729-9698-E5AA13183FF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5A210-0E15-4F55-963C-5BADE2DC5EF2}" type="datetimeFigureOut">
              <a:rPr lang="en-US" smtClean="0"/>
              <a:pPr/>
              <a:t>11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D5225-7804-4729-9698-E5AA13183FF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5A210-0E15-4F55-963C-5BADE2DC5EF2}" type="datetimeFigureOut">
              <a:rPr lang="en-US" smtClean="0"/>
              <a:pPr/>
              <a:t>11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D5225-7804-4729-9698-E5AA13183FF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5A210-0E15-4F55-963C-5BADE2DC5EF2}" type="datetimeFigureOut">
              <a:rPr lang="en-US" smtClean="0"/>
              <a:pPr/>
              <a:t>11/1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D5225-7804-4729-9698-E5AA13183FF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5A210-0E15-4F55-963C-5BADE2DC5EF2}" type="datetimeFigureOut">
              <a:rPr lang="en-US" smtClean="0"/>
              <a:pPr/>
              <a:t>11/1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D5225-7804-4729-9698-E5AA13183FF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5A210-0E15-4F55-963C-5BADE2DC5EF2}" type="datetimeFigureOut">
              <a:rPr lang="en-US" smtClean="0"/>
              <a:pPr/>
              <a:t>11/1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D5225-7804-4729-9698-E5AA13183FF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5A210-0E15-4F55-963C-5BADE2DC5EF2}" type="datetimeFigureOut">
              <a:rPr lang="en-US" smtClean="0"/>
              <a:pPr/>
              <a:t>11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D5225-7804-4729-9698-E5AA13183FF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5A210-0E15-4F55-963C-5BADE2DC5EF2}" type="datetimeFigureOut">
              <a:rPr lang="en-US" smtClean="0"/>
              <a:pPr/>
              <a:t>11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4D5225-7804-4729-9698-E5AA13183FF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85A210-0E15-4F55-963C-5BADE2DC5EF2}" type="datetimeFigureOut">
              <a:rPr lang="en-US" smtClean="0"/>
              <a:pPr/>
              <a:t>11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4D5225-7804-4729-9698-E5AA13183FF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89951" y="657371"/>
            <a:ext cx="5549558" cy="45336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05481" y="951471"/>
            <a:ext cx="4226947" cy="35869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6" name="Group 75"/>
          <p:cNvGrpSpPr/>
          <p:nvPr/>
        </p:nvGrpSpPr>
        <p:grpSpPr>
          <a:xfrm>
            <a:off x="902044" y="432486"/>
            <a:ext cx="3744098" cy="8328456"/>
            <a:chOff x="902044" y="432486"/>
            <a:chExt cx="3744098" cy="8328456"/>
          </a:xfrm>
        </p:grpSpPr>
        <p:sp>
          <p:nvSpPr>
            <p:cNvPr id="75" name="Rectangle 74"/>
            <p:cNvSpPr/>
            <p:nvPr/>
          </p:nvSpPr>
          <p:spPr>
            <a:xfrm>
              <a:off x="902044" y="432486"/>
              <a:ext cx="3744098" cy="83284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74" name="Group 73"/>
            <p:cNvGrpSpPr/>
            <p:nvPr/>
          </p:nvGrpSpPr>
          <p:grpSpPr>
            <a:xfrm>
              <a:off x="1001486" y="548643"/>
              <a:ext cx="3487370" cy="8003873"/>
              <a:chOff x="1001486" y="548643"/>
              <a:chExt cx="3487370" cy="8003873"/>
            </a:xfrm>
          </p:grpSpPr>
          <p:grpSp>
            <p:nvGrpSpPr>
              <p:cNvPr id="69" name="Group 68"/>
              <p:cNvGrpSpPr/>
              <p:nvPr/>
            </p:nvGrpSpPr>
            <p:grpSpPr>
              <a:xfrm>
                <a:off x="1259359" y="757034"/>
                <a:ext cx="3229497" cy="7795482"/>
                <a:chOff x="562573" y="414690"/>
                <a:chExt cx="3229497" cy="7795482"/>
              </a:xfrm>
            </p:grpSpPr>
            <p:grpSp>
              <p:nvGrpSpPr>
                <p:cNvPr id="60" name="Group 59"/>
                <p:cNvGrpSpPr/>
                <p:nvPr/>
              </p:nvGrpSpPr>
              <p:grpSpPr>
                <a:xfrm>
                  <a:off x="1006867" y="470652"/>
                  <a:ext cx="2785203" cy="2320050"/>
                  <a:chOff x="3561809" y="1680884"/>
                  <a:chExt cx="2785203" cy="2320050"/>
                </a:xfrm>
              </p:grpSpPr>
              <p:pic>
                <p:nvPicPr>
                  <p:cNvPr id="6" name="Picture 3"/>
                  <p:cNvPicPr>
                    <a:picLocks noChangeAspect="1" noChangeArrowheads="1"/>
                  </p:cNvPicPr>
                  <p:nvPr/>
                </p:nvPicPr>
                <p:blipFill>
                  <a:blip r:embed="rId2" cstate="print"/>
                  <a:srcRect l="6368" t="4543" r="69071" b="76198"/>
                  <a:stretch>
                    <a:fillRect/>
                  </a:stretch>
                </p:blipFill>
                <p:spPr bwMode="auto">
                  <a:xfrm>
                    <a:off x="4114807" y="1680884"/>
                    <a:ext cx="2232205" cy="174811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sp>
                <p:nvSpPr>
                  <p:cNvPr id="9" name="TextBox 8"/>
                  <p:cNvSpPr txBox="1"/>
                  <p:nvPr/>
                </p:nvSpPr>
                <p:spPr>
                  <a:xfrm>
                    <a:off x="3561809" y="2518976"/>
                    <a:ext cx="583814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0.10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0" name="TextBox 9"/>
                  <p:cNvSpPr txBox="1"/>
                  <p:nvPr/>
                </p:nvSpPr>
                <p:spPr>
                  <a:xfrm>
                    <a:off x="3561809" y="3076018"/>
                    <a:ext cx="583814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0.00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1" name="TextBox 10"/>
                  <p:cNvSpPr txBox="1"/>
                  <p:nvPr/>
                </p:nvSpPr>
                <p:spPr>
                  <a:xfrm>
                    <a:off x="3561809" y="1961932"/>
                    <a:ext cx="583814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0.20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2" name="TextBox 11"/>
                  <p:cNvSpPr txBox="1"/>
                  <p:nvPr/>
                </p:nvSpPr>
                <p:spPr>
                  <a:xfrm>
                    <a:off x="3561809" y="2240454"/>
                    <a:ext cx="583814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0.15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3" name="TextBox 12"/>
                  <p:cNvSpPr txBox="1"/>
                  <p:nvPr/>
                </p:nvSpPr>
                <p:spPr>
                  <a:xfrm>
                    <a:off x="3561809" y="2797498"/>
                    <a:ext cx="583814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0.05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4" name="TextBox 13"/>
                  <p:cNvSpPr txBox="1"/>
                  <p:nvPr/>
                </p:nvSpPr>
                <p:spPr>
                  <a:xfrm>
                    <a:off x="3561809" y="1683410"/>
                    <a:ext cx="583814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0.25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5" name="TextBox 14"/>
                  <p:cNvSpPr txBox="1"/>
                  <p:nvPr/>
                </p:nvSpPr>
                <p:spPr>
                  <a:xfrm rot="5400000">
                    <a:off x="4189254" y="3355267"/>
                    <a:ext cx="298480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1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6" name="TextBox 15"/>
                  <p:cNvSpPr txBox="1"/>
                  <p:nvPr/>
                </p:nvSpPr>
                <p:spPr>
                  <a:xfrm rot="5400000">
                    <a:off x="4592386" y="3369556"/>
                    <a:ext cx="298480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7" name="TextBox 16"/>
                  <p:cNvSpPr txBox="1"/>
                  <p:nvPr/>
                </p:nvSpPr>
                <p:spPr>
                  <a:xfrm rot="5400000">
                    <a:off x="4706896" y="3407410"/>
                    <a:ext cx="412292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10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8" name="TextBox 17"/>
                  <p:cNvSpPr txBox="1"/>
                  <p:nvPr/>
                </p:nvSpPr>
                <p:spPr>
                  <a:xfrm rot="5400000">
                    <a:off x="5106947" y="3426462"/>
                    <a:ext cx="412292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50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9" name="TextBox 18"/>
                  <p:cNvSpPr txBox="1"/>
                  <p:nvPr/>
                </p:nvSpPr>
                <p:spPr>
                  <a:xfrm rot="5400000">
                    <a:off x="5227061" y="3459554"/>
                    <a:ext cx="526106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100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0" name="TextBox 19"/>
                  <p:cNvSpPr txBox="1"/>
                  <p:nvPr/>
                </p:nvSpPr>
                <p:spPr>
                  <a:xfrm rot="5400000">
                    <a:off x="5625429" y="3483369"/>
                    <a:ext cx="526106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500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1" name="TextBox 20"/>
                  <p:cNvSpPr txBox="1"/>
                  <p:nvPr/>
                </p:nvSpPr>
                <p:spPr>
                  <a:xfrm rot="5400000">
                    <a:off x="5743019" y="3511698"/>
                    <a:ext cx="639919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1000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57" name="TextBox 56"/>
                  <p:cNvSpPr txBox="1"/>
                  <p:nvPr/>
                </p:nvSpPr>
                <p:spPr>
                  <a:xfrm>
                    <a:off x="5741893" y="1788459"/>
                    <a:ext cx="543739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AFR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grpSp>
              <p:nvGrpSpPr>
                <p:cNvPr id="61" name="Group 60"/>
                <p:cNvGrpSpPr/>
                <p:nvPr/>
              </p:nvGrpSpPr>
              <p:grpSpPr>
                <a:xfrm>
                  <a:off x="999010" y="2992261"/>
                  <a:ext cx="2779613" cy="2411652"/>
                  <a:chOff x="3419481" y="4148704"/>
                  <a:chExt cx="2779613" cy="2411652"/>
                </a:xfrm>
              </p:grpSpPr>
              <p:pic>
                <p:nvPicPr>
                  <p:cNvPr id="7" name="Picture 3"/>
                  <p:cNvPicPr>
                    <a:picLocks noChangeAspect="1" noChangeArrowheads="1"/>
                  </p:cNvPicPr>
                  <p:nvPr/>
                </p:nvPicPr>
                <p:blipFill>
                  <a:blip r:embed="rId2" cstate="print"/>
                  <a:srcRect l="6319" t="39457" r="69269" b="41136"/>
                  <a:stretch>
                    <a:fillRect/>
                  </a:stretch>
                </p:blipFill>
                <p:spPr bwMode="auto">
                  <a:xfrm>
                    <a:off x="3980335" y="4182034"/>
                    <a:ext cx="2218759" cy="1761564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sp>
                <p:nvSpPr>
                  <p:cNvPr id="22" name="TextBox 21"/>
                  <p:cNvSpPr txBox="1"/>
                  <p:nvPr/>
                </p:nvSpPr>
                <p:spPr>
                  <a:xfrm rot="5400000">
                    <a:off x="4072702" y="5914689"/>
                    <a:ext cx="298480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1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3" name="TextBox 22"/>
                  <p:cNvSpPr txBox="1"/>
                  <p:nvPr/>
                </p:nvSpPr>
                <p:spPr>
                  <a:xfrm rot="5400000">
                    <a:off x="4475834" y="5928978"/>
                    <a:ext cx="298480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4" name="TextBox 23"/>
                  <p:cNvSpPr txBox="1"/>
                  <p:nvPr/>
                </p:nvSpPr>
                <p:spPr>
                  <a:xfrm rot="5400000">
                    <a:off x="4590344" y="5966832"/>
                    <a:ext cx="412292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10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5" name="TextBox 24"/>
                  <p:cNvSpPr txBox="1"/>
                  <p:nvPr/>
                </p:nvSpPr>
                <p:spPr>
                  <a:xfrm rot="5400000">
                    <a:off x="4990395" y="5985884"/>
                    <a:ext cx="412292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50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6" name="TextBox 25"/>
                  <p:cNvSpPr txBox="1"/>
                  <p:nvPr/>
                </p:nvSpPr>
                <p:spPr>
                  <a:xfrm rot="5400000">
                    <a:off x="5110509" y="6018976"/>
                    <a:ext cx="526106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100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7" name="TextBox 26"/>
                  <p:cNvSpPr txBox="1"/>
                  <p:nvPr/>
                </p:nvSpPr>
                <p:spPr>
                  <a:xfrm rot="5400000">
                    <a:off x="5508877" y="6042791"/>
                    <a:ext cx="526106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500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8" name="TextBox 27"/>
                  <p:cNvSpPr txBox="1"/>
                  <p:nvPr/>
                </p:nvSpPr>
                <p:spPr>
                  <a:xfrm rot="5400000">
                    <a:off x="5626467" y="6071120"/>
                    <a:ext cx="639919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1000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9" name="TextBox 38"/>
                  <p:cNvSpPr txBox="1"/>
                  <p:nvPr/>
                </p:nvSpPr>
                <p:spPr>
                  <a:xfrm>
                    <a:off x="3419481" y="4984270"/>
                    <a:ext cx="583814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0.10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0" name="TextBox 39"/>
                  <p:cNvSpPr txBox="1"/>
                  <p:nvPr/>
                </p:nvSpPr>
                <p:spPr>
                  <a:xfrm>
                    <a:off x="3419481" y="5541312"/>
                    <a:ext cx="583814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0.00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1" name="TextBox 40"/>
                  <p:cNvSpPr txBox="1"/>
                  <p:nvPr/>
                </p:nvSpPr>
                <p:spPr>
                  <a:xfrm>
                    <a:off x="3419481" y="4427226"/>
                    <a:ext cx="583814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0.20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2" name="TextBox 41"/>
                  <p:cNvSpPr txBox="1"/>
                  <p:nvPr/>
                </p:nvSpPr>
                <p:spPr>
                  <a:xfrm>
                    <a:off x="3419481" y="4705748"/>
                    <a:ext cx="583814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0.15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3" name="TextBox 42"/>
                  <p:cNvSpPr txBox="1"/>
                  <p:nvPr/>
                </p:nvSpPr>
                <p:spPr>
                  <a:xfrm>
                    <a:off x="3419481" y="5262792"/>
                    <a:ext cx="583814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0.05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4" name="TextBox 43"/>
                  <p:cNvSpPr txBox="1"/>
                  <p:nvPr/>
                </p:nvSpPr>
                <p:spPr>
                  <a:xfrm>
                    <a:off x="3419481" y="4148704"/>
                    <a:ext cx="583814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0.25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58" name="TextBox 57"/>
                  <p:cNvSpPr txBox="1"/>
                  <p:nvPr/>
                </p:nvSpPr>
                <p:spPr>
                  <a:xfrm>
                    <a:off x="5625352" y="4280648"/>
                    <a:ext cx="545342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SEA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grpSp>
              <p:nvGrpSpPr>
                <p:cNvPr id="62" name="Group 61"/>
                <p:cNvGrpSpPr/>
                <p:nvPr/>
              </p:nvGrpSpPr>
              <p:grpSpPr>
                <a:xfrm>
                  <a:off x="990046" y="5580534"/>
                  <a:ext cx="2775131" cy="2463487"/>
                  <a:chOff x="3464305" y="6925235"/>
                  <a:chExt cx="2775131" cy="2463487"/>
                </a:xfrm>
              </p:grpSpPr>
              <p:pic>
                <p:nvPicPr>
                  <p:cNvPr id="8" name="Picture 3"/>
                  <p:cNvPicPr>
                    <a:picLocks noChangeAspect="1" noChangeArrowheads="1"/>
                  </p:cNvPicPr>
                  <p:nvPr/>
                </p:nvPicPr>
                <p:blipFill>
                  <a:blip r:embed="rId2" cstate="print"/>
                  <a:srcRect l="5774" t="73185" r="69369" b="6667"/>
                  <a:stretch>
                    <a:fillRect/>
                  </a:stretch>
                </p:blipFill>
                <p:spPr bwMode="auto">
                  <a:xfrm>
                    <a:off x="3980336" y="6925235"/>
                    <a:ext cx="2259100" cy="18288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sp>
                <p:nvSpPr>
                  <p:cNvPr id="29" name="TextBox 28"/>
                  <p:cNvSpPr txBox="1"/>
                  <p:nvPr/>
                </p:nvSpPr>
                <p:spPr>
                  <a:xfrm rot="5400000">
                    <a:off x="4117518" y="8743055"/>
                    <a:ext cx="298480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1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0" name="TextBox 29"/>
                  <p:cNvSpPr txBox="1"/>
                  <p:nvPr/>
                </p:nvSpPr>
                <p:spPr>
                  <a:xfrm rot="5400000">
                    <a:off x="4520650" y="8757344"/>
                    <a:ext cx="298480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1" name="TextBox 30"/>
                  <p:cNvSpPr txBox="1"/>
                  <p:nvPr/>
                </p:nvSpPr>
                <p:spPr>
                  <a:xfrm rot="5400000">
                    <a:off x="4635160" y="8795198"/>
                    <a:ext cx="412292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10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2" name="TextBox 31"/>
                  <p:cNvSpPr txBox="1"/>
                  <p:nvPr/>
                </p:nvSpPr>
                <p:spPr>
                  <a:xfrm rot="5400000">
                    <a:off x="5035211" y="8814250"/>
                    <a:ext cx="412292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50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3" name="TextBox 32"/>
                  <p:cNvSpPr txBox="1"/>
                  <p:nvPr/>
                </p:nvSpPr>
                <p:spPr>
                  <a:xfrm rot="5400000">
                    <a:off x="5155325" y="8847342"/>
                    <a:ext cx="526106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100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4" name="TextBox 33"/>
                  <p:cNvSpPr txBox="1"/>
                  <p:nvPr/>
                </p:nvSpPr>
                <p:spPr>
                  <a:xfrm rot="5400000">
                    <a:off x="5553693" y="8871157"/>
                    <a:ext cx="526106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500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5" name="TextBox 34"/>
                  <p:cNvSpPr txBox="1"/>
                  <p:nvPr/>
                </p:nvSpPr>
                <p:spPr>
                  <a:xfrm rot="5400000">
                    <a:off x="5671283" y="8899486"/>
                    <a:ext cx="639919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1000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51" name="TextBox 50"/>
                  <p:cNvSpPr txBox="1"/>
                  <p:nvPr/>
                </p:nvSpPr>
                <p:spPr>
                  <a:xfrm>
                    <a:off x="3464305" y="7812634"/>
                    <a:ext cx="583814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0.10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52" name="TextBox 51"/>
                  <p:cNvSpPr txBox="1"/>
                  <p:nvPr/>
                </p:nvSpPr>
                <p:spPr>
                  <a:xfrm>
                    <a:off x="3464305" y="8369676"/>
                    <a:ext cx="583814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0.00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53" name="TextBox 52"/>
                  <p:cNvSpPr txBox="1"/>
                  <p:nvPr/>
                </p:nvSpPr>
                <p:spPr>
                  <a:xfrm>
                    <a:off x="3464305" y="7255590"/>
                    <a:ext cx="583814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0.20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54" name="TextBox 53"/>
                  <p:cNvSpPr txBox="1"/>
                  <p:nvPr/>
                </p:nvSpPr>
                <p:spPr>
                  <a:xfrm>
                    <a:off x="3464305" y="7534112"/>
                    <a:ext cx="583814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0.15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55" name="TextBox 54"/>
                  <p:cNvSpPr txBox="1"/>
                  <p:nvPr/>
                </p:nvSpPr>
                <p:spPr>
                  <a:xfrm>
                    <a:off x="3464305" y="8091156"/>
                    <a:ext cx="583814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0.05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56" name="TextBox 55"/>
                  <p:cNvSpPr txBox="1"/>
                  <p:nvPr/>
                </p:nvSpPr>
                <p:spPr>
                  <a:xfrm>
                    <a:off x="3464305" y="6977068"/>
                    <a:ext cx="583814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smtClean="0">
                        <a:latin typeface="Arial" pitchFamily="34" charset="0"/>
                        <a:cs typeface="Arial" pitchFamily="34" charset="0"/>
                      </a:rPr>
                      <a:t>0.25</a:t>
                    </a:r>
                    <a:endParaRPr lang="en-US" sz="1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59" name="TextBox 58"/>
                  <p:cNvSpPr txBox="1"/>
                  <p:nvPr/>
                </p:nvSpPr>
                <p:spPr>
                  <a:xfrm>
                    <a:off x="5643282" y="7095564"/>
                    <a:ext cx="574196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dirty="0" smtClean="0">
                        <a:latin typeface="Arial" pitchFamily="34" charset="0"/>
                        <a:cs typeface="Arial" pitchFamily="34" charset="0"/>
                      </a:rPr>
                      <a:t>SAM</a:t>
                    </a:r>
                    <a:endParaRPr lang="en-US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63" name="TextBox 62"/>
                <p:cNvSpPr txBox="1"/>
                <p:nvPr/>
              </p:nvSpPr>
              <p:spPr>
                <a:xfrm rot="16200000">
                  <a:off x="-80577" y="1075769"/>
                  <a:ext cx="1845377" cy="523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Allele frequency </a:t>
                  </a:r>
                </a:p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of deleterious variant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4" name="TextBox 63"/>
                <p:cNvSpPr txBox="1"/>
                <p:nvPr/>
              </p:nvSpPr>
              <p:spPr>
                <a:xfrm rot="16200000">
                  <a:off x="-89541" y="3594851"/>
                  <a:ext cx="1845377" cy="523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Allele frequency </a:t>
                  </a:r>
                </a:p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of deleterious variant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5" name="TextBox 64"/>
                <p:cNvSpPr txBox="1"/>
                <p:nvPr/>
              </p:nvSpPr>
              <p:spPr>
                <a:xfrm rot="16200000">
                  <a:off x="-98506" y="6248405"/>
                  <a:ext cx="1845377" cy="523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Allele frequency </a:t>
                  </a:r>
                </a:p>
                <a:p>
                  <a:pPr algn="ctr"/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of deleterious variant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6" name="TextBox 65"/>
                <p:cNvSpPr txBox="1"/>
                <p:nvPr/>
              </p:nvSpPr>
              <p:spPr>
                <a:xfrm>
                  <a:off x="2030506" y="5257803"/>
                  <a:ext cx="150714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Generations ago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7" name="TextBox 66"/>
                <p:cNvSpPr txBox="1"/>
                <p:nvPr/>
              </p:nvSpPr>
              <p:spPr>
                <a:xfrm>
                  <a:off x="1994646" y="2653556"/>
                  <a:ext cx="150714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Generations ago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8" name="TextBox 67"/>
                <p:cNvSpPr txBox="1"/>
                <p:nvPr/>
              </p:nvSpPr>
              <p:spPr>
                <a:xfrm>
                  <a:off x="2012575" y="7902395"/>
                  <a:ext cx="150714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 smtClean="0">
                      <a:latin typeface="Arial" pitchFamily="34" charset="0"/>
                      <a:cs typeface="Arial" pitchFamily="34" charset="0"/>
                    </a:rPr>
                    <a:t>Generations ago</a:t>
                  </a:r>
                  <a:endParaRPr 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71" name="TextBox 70"/>
              <p:cNvSpPr txBox="1"/>
              <p:nvPr/>
            </p:nvSpPr>
            <p:spPr>
              <a:xfrm>
                <a:off x="1001486" y="548643"/>
                <a:ext cx="3177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A</a:t>
                </a:r>
                <a:endParaRPr lang="en-US" dirty="0"/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1001486" y="3065420"/>
                <a:ext cx="30970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B</a:t>
                </a:r>
                <a:endParaRPr lang="en-US" dirty="0"/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1001486" y="5725894"/>
                <a:ext cx="308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C</a:t>
                </a:r>
                <a:endParaRPr lang="en-US" dirty="0"/>
              </a:p>
            </p:txBody>
          </p:sp>
        </p:grp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 t="7045"/>
          <a:stretch>
            <a:fillRect/>
          </a:stretch>
        </p:blipFill>
        <p:spPr bwMode="auto">
          <a:xfrm rot="5400000">
            <a:off x="381000" y="232920"/>
            <a:ext cx="4419600" cy="95206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65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09600" y="446432"/>
            <a:ext cx="5880481" cy="42033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/>
          <p:cNvGrpSpPr/>
          <p:nvPr/>
        </p:nvGrpSpPr>
        <p:grpSpPr>
          <a:xfrm>
            <a:off x="-1" y="370703"/>
            <a:ext cx="6872594" cy="5339253"/>
            <a:chOff x="-1" y="370703"/>
            <a:chExt cx="6872594" cy="5339253"/>
          </a:xfrm>
        </p:grpSpPr>
        <p:sp>
          <p:nvSpPr>
            <p:cNvPr id="19" name="Rectangle 18"/>
            <p:cNvSpPr/>
            <p:nvPr/>
          </p:nvSpPr>
          <p:spPr>
            <a:xfrm>
              <a:off x="-1" y="370703"/>
              <a:ext cx="6858001" cy="528869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8" name="Group 17"/>
            <p:cNvGrpSpPr/>
            <p:nvPr/>
          </p:nvGrpSpPr>
          <p:grpSpPr>
            <a:xfrm>
              <a:off x="76200" y="381000"/>
              <a:ext cx="6796393" cy="5328956"/>
              <a:chOff x="76200" y="381000"/>
              <a:chExt cx="6796393" cy="5328956"/>
            </a:xfrm>
          </p:grpSpPr>
          <p:pic>
            <p:nvPicPr>
              <p:cNvPr id="9218" name="Picture 2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76200" y="447675"/>
                <a:ext cx="6632575" cy="47259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4651375" y="381000"/>
                <a:ext cx="1981200" cy="164031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cxnSp>
            <p:nvCxnSpPr>
              <p:cNvPr id="5" name="Straight Arrow Connector 4"/>
              <p:cNvCxnSpPr/>
              <p:nvPr/>
            </p:nvCxnSpPr>
            <p:spPr>
              <a:xfrm>
                <a:off x="298450" y="5248275"/>
                <a:ext cx="205740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" name="Straight Arrow Connector 5"/>
              <p:cNvCxnSpPr/>
              <p:nvPr/>
            </p:nvCxnSpPr>
            <p:spPr>
              <a:xfrm>
                <a:off x="2641600" y="5248275"/>
                <a:ext cx="411480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TextBox 11"/>
              <p:cNvSpPr txBox="1"/>
              <p:nvPr/>
            </p:nvSpPr>
            <p:spPr>
              <a:xfrm rot="5400000">
                <a:off x="162111" y="5208716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0</a:t>
                </a:r>
                <a:endParaRPr lang="en-US" sz="1200" dirty="0"/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 rot="5400000">
                <a:off x="2096151" y="5342066"/>
                <a:ext cx="4587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1.75</a:t>
                </a:r>
                <a:endParaRPr lang="en-US" sz="1200" dirty="0"/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 rot="5400000">
                <a:off x="6543978" y="5303966"/>
                <a:ext cx="3802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3.5</a:t>
                </a: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 rot="5400000">
                <a:off x="2495736" y="5208716"/>
                <a:ext cx="2632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0</a:t>
                </a:r>
                <a:endParaRPr lang="en-US" sz="1200" dirty="0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361950" y="5248275"/>
                <a:ext cx="19716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Chromosome position (Mb)</a:t>
                </a:r>
                <a:endParaRPr lang="en-US" sz="1200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3571874" y="5238750"/>
                <a:ext cx="19716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Chromosome position (Mb)</a:t>
                </a:r>
                <a:endParaRPr lang="en-US" sz="1200" dirty="0"/>
              </a:p>
            </p:txBody>
          </p:sp>
        </p:grp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74670" y="457200"/>
            <a:ext cx="6062029" cy="8534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9514" y="656710"/>
            <a:ext cx="6194854" cy="19383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82625" y="1173163"/>
            <a:ext cx="5156200" cy="7534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 rot="5400000">
            <a:off x="1117600" y="555625"/>
            <a:ext cx="3224213" cy="8856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 rot="5400000">
            <a:off x="457199" y="381000"/>
            <a:ext cx="5977453" cy="8915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409</TotalTime>
  <Words>80</Words>
  <Application>Microsoft Office PowerPoint</Application>
  <PresentationFormat>A4 Paper (210x297 mm)</PresentationFormat>
  <Paragraphs>60</Paragraphs>
  <Slides>1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2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ianc</dc:creator>
  <cp:lastModifiedBy>ianc</cp:lastModifiedBy>
  <cp:revision>1365</cp:revision>
  <dcterms:created xsi:type="dcterms:W3CDTF">2014-11-12T20:35:24Z</dcterms:created>
  <dcterms:modified xsi:type="dcterms:W3CDTF">2015-11-11T23:12:20Z</dcterms:modified>
</cp:coreProperties>
</file>